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82" d="100"/>
          <a:sy n="82" d="100"/>
        </p:scale>
        <p:origin x="1614" y="11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Word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Word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Word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Chart%202%20in%20Microsoft%20Word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Chart%203%20in%20Microsoft%20Word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Chart%203%20in%20Microsoft%20Word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GSK</a:t>
            </a:r>
            <a:r>
              <a:rPr lang="en-GB" baseline="0"/>
              <a:t> A</a:t>
            </a:r>
            <a:endParaRPr lang="en-GB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hart in Microsoft Word]GEVFNAT'!$B$36:$B$43</c:f>
              <c:strCache>
                <c:ptCount val="8"/>
                <c:pt idx="0">
                  <c:v>GEVFNAT G0F</c:v>
                </c:pt>
                <c:pt idx="1">
                  <c:v>GEVFNAT G1</c:v>
                </c:pt>
                <c:pt idx="2">
                  <c:v>GEVFNAT G1F</c:v>
                </c:pt>
                <c:pt idx="3">
                  <c:v>GEVFNAT G2</c:v>
                </c:pt>
                <c:pt idx="4">
                  <c:v>GEVFNAT G2F</c:v>
                </c:pt>
                <c:pt idx="5">
                  <c:v>GEVFNAT A1F</c:v>
                </c:pt>
                <c:pt idx="6">
                  <c:v>GEVFNAT A1F-Gal</c:v>
                </c:pt>
                <c:pt idx="7">
                  <c:v>GEVFNAT A2F</c:v>
                </c:pt>
              </c:strCache>
            </c:strRef>
          </c:cat>
          <c:val>
            <c:numRef>
              <c:f>'[Chart in Microsoft Word]GEVFNAT'!$C$36:$C$43</c:f>
              <c:numCache>
                <c:formatCode>General</c:formatCode>
                <c:ptCount val="8"/>
                <c:pt idx="0">
                  <c:v>2741598</c:v>
                </c:pt>
                <c:pt idx="1">
                  <c:v>677284</c:v>
                </c:pt>
                <c:pt idx="2">
                  <c:v>1129632</c:v>
                </c:pt>
                <c:pt idx="3">
                  <c:v>747877</c:v>
                </c:pt>
                <c:pt idx="4">
                  <c:v>2502975</c:v>
                </c:pt>
                <c:pt idx="5">
                  <c:v>1242706</c:v>
                </c:pt>
                <c:pt idx="6">
                  <c:v>1325241</c:v>
                </c:pt>
                <c:pt idx="7">
                  <c:v>10966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F3-4922-A54C-5A7AB56596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1226400"/>
        <c:axId val="431232960"/>
      </c:barChart>
      <c:catAx>
        <c:axId val="431226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232960"/>
        <c:crosses val="autoZero"/>
        <c:auto val="1"/>
        <c:lblAlgn val="ctr"/>
        <c:lblOffset val="100"/>
        <c:noMultiLvlLbl val="0"/>
      </c:catAx>
      <c:valAx>
        <c:axId val="431232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226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GSK B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hart in Microsoft Word]GEVFNAT'!$I$36:$I$43</c:f>
              <c:strCache>
                <c:ptCount val="8"/>
                <c:pt idx="0">
                  <c:v>GEVFNAT G0F</c:v>
                </c:pt>
                <c:pt idx="1">
                  <c:v>GEVFNAT G1</c:v>
                </c:pt>
                <c:pt idx="2">
                  <c:v>GEVFNAT G1F</c:v>
                </c:pt>
                <c:pt idx="3">
                  <c:v>GEVFNAT G2</c:v>
                </c:pt>
                <c:pt idx="4">
                  <c:v>GEVFNAT G2F</c:v>
                </c:pt>
                <c:pt idx="5">
                  <c:v>GEVFNAT A1F</c:v>
                </c:pt>
                <c:pt idx="6">
                  <c:v>GEVFNAT A1F-Gal</c:v>
                </c:pt>
                <c:pt idx="7">
                  <c:v>GEVFNAT A2F</c:v>
                </c:pt>
              </c:strCache>
            </c:strRef>
          </c:cat>
          <c:val>
            <c:numRef>
              <c:f>'[Chart in Microsoft Word]GEVFNAT'!$J$36:$J$43</c:f>
              <c:numCache>
                <c:formatCode>General</c:formatCode>
                <c:ptCount val="8"/>
                <c:pt idx="0">
                  <c:v>2168903</c:v>
                </c:pt>
                <c:pt idx="1">
                  <c:v>588799</c:v>
                </c:pt>
                <c:pt idx="2">
                  <c:v>973086</c:v>
                </c:pt>
                <c:pt idx="3">
                  <c:v>679945</c:v>
                </c:pt>
                <c:pt idx="4">
                  <c:v>2049471</c:v>
                </c:pt>
                <c:pt idx="5">
                  <c:v>1318771</c:v>
                </c:pt>
                <c:pt idx="6">
                  <c:v>1442069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24-4A5F-99D7-3D2E0448DA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2049424"/>
        <c:axId val="472040240"/>
      </c:barChart>
      <c:catAx>
        <c:axId val="472049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2040240"/>
        <c:crosses val="autoZero"/>
        <c:auto val="1"/>
        <c:lblAlgn val="ctr"/>
        <c:lblOffset val="100"/>
        <c:noMultiLvlLbl val="0"/>
      </c:catAx>
      <c:valAx>
        <c:axId val="4720402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2049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GSK</a:t>
            </a:r>
            <a:r>
              <a:rPr lang="en-GB" baseline="0"/>
              <a:t> C</a:t>
            </a:r>
            <a:endParaRPr lang="en-GB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hart in Microsoft Word]GEVFNAT'!$P$36:$P$43</c:f>
              <c:strCache>
                <c:ptCount val="8"/>
                <c:pt idx="0">
                  <c:v>GEVFNAT G0F</c:v>
                </c:pt>
                <c:pt idx="1">
                  <c:v>GEVFNAT G1</c:v>
                </c:pt>
                <c:pt idx="2">
                  <c:v>GEVFNAT G1F</c:v>
                </c:pt>
                <c:pt idx="3">
                  <c:v>GEVFNAT G2</c:v>
                </c:pt>
                <c:pt idx="4">
                  <c:v>GEVFNAT G2F</c:v>
                </c:pt>
                <c:pt idx="5">
                  <c:v>GEVFNAT A1F</c:v>
                </c:pt>
                <c:pt idx="6">
                  <c:v>GEVFNAT A1F-Gal</c:v>
                </c:pt>
                <c:pt idx="7">
                  <c:v>GEVFNAT A2F</c:v>
                </c:pt>
              </c:strCache>
            </c:strRef>
          </c:cat>
          <c:val>
            <c:numRef>
              <c:f>'[Chart in Microsoft Word]GEVFNAT'!$Q$36:$Q$43</c:f>
              <c:numCache>
                <c:formatCode>General</c:formatCode>
                <c:ptCount val="8"/>
                <c:pt idx="0">
                  <c:v>2755161</c:v>
                </c:pt>
                <c:pt idx="1">
                  <c:v>700121</c:v>
                </c:pt>
                <c:pt idx="2">
                  <c:v>1579297</c:v>
                </c:pt>
                <c:pt idx="3">
                  <c:v>856165</c:v>
                </c:pt>
                <c:pt idx="4">
                  <c:v>2324828</c:v>
                </c:pt>
                <c:pt idx="5">
                  <c:v>2364160</c:v>
                </c:pt>
                <c:pt idx="6">
                  <c:v>1965104</c:v>
                </c:pt>
                <c:pt idx="7">
                  <c:v>7888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02-4D47-8054-0478E05ECE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9299040"/>
        <c:axId val="469301008"/>
      </c:barChart>
      <c:catAx>
        <c:axId val="469299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9301008"/>
        <c:crosses val="autoZero"/>
        <c:auto val="1"/>
        <c:lblAlgn val="ctr"/>
        <c:lblOffset val="100"/>
        <c:noMultiLvlLbl val="0"/>
      </c:catAx>
      <c:valAx>
        <c:axId val="469301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9299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GSK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hart 2 in Microsoft Word]NLCPFGEVFNAT'!$B$36:$B$51</c:f>
              <c:strCache>
                <c:ptCount val="16"/>
                <c:pt idx="0">
                  <c:v>NLCPFGEVFNAT glyco</c:v>
                </c:pt>
                <c:pt idx="1">
                  <c:v>NLCPFGEVFNAT Man4</c:v>
                </c:pt>
                <c:pt idx="2">
                  <c:v>NLCPFGEVFNAT Man5</c:v>
                </c:pt>
                <c:pt idx="3">
                  <c:v>NLCPFGEVFNAT Man6</c:v>
                </c:pt>
                <c:pt idx="4">
                  <c:v>NLCPFGEVFNAT Man7</c:v>
                </c:pt>
                <c:pt idx="5">
                  <c:v>NLCPFGEVFNAT Man8</c:v>
                </c:pt>
                <c:pt idx="6">
                  <c:v>NLCPFGEVFNAT G0F</c:v>
                </c:pt>
                <c:pt idx="7">
                  <c:v>NLCPFGEVFNAT G0F+GlcNAc</c:v>
                </c:pt>
                <c:pt idx="8">
                  <c:v>NLCPFGEVFNAT G1F</c:v>
                </c:pt>
                <c:pt idx="9">
                  <c:v>NLCPFGEVFNAT G2F</c:v>
                </c:pt>
                <c:pt idx="10">
                  <c:v>NLCPFGEVFNAT G2(F)</c:v>
                </c:pt>
                <c:pt idx="11">
                  <c:v>NLCPFGEVFNAT A1F</c:v>
                </c:pt>
                <c:pt idx="12">
                  <c:v>NLCPFGEVFNAT A2F</c:v>
                </c:pt>
                <c:pt idx="13">
                  <c:v>NLCPFGEVFNAT Complex</c:v>
                </c:pt>
                <c:pt idx="14">
                  <c:v>NLCPFGEVFNAT Complex + Hex</c:v>
                </c:pt>
                <c:pt idx="15">
                  <c:v>NLCPFGEVFNAT Complex + Hex - Fuc</c:v>
                </c:pt>
              </c:strCache>
            </c:strRef>
          </c:cat>
          <c:val>
            <c:numRef>
              <c:f>'[Chart 2 in Microsoft Word]NLCPFGEVFNAT'!$C$36:$C$51</c:f>
              <c:numCache>
                <c:formatCode>General</c:formatCode>
                <c:ptCount val="16"/>
                <c:pt idx="0">
                  <c:v>612382</c:v>
                </c:pt>
                <c:pt idx="1">
                  <c:v>0</c:v>
                </c:pt>
                <c:pt idx="2">
                  <c:v>86800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797937</c:v>
                </c:pt>
                <c:pt idx="7">
                  <c:v>0</c:v>
                </c:pt>
                <c:pt idx="8">
                  <c:v>3869392</c:v>
                </c:pt>
                <c:pt idx="9">
                  <c:v>5401840</c:v>
                </c:pt>
                <c:pt idx="10">
                  <c:v>0</c:v>
                </c:pt>
                <c:pt idx="11">
                  <c:v>1631877</c:v>
                </c:pt>
                <c:pt idx="12">
                  <c:v>3248884</c:v>
                </c:pt>
                <c:pt idx="13">
                  <c:v>5730950</c:v>
                </c:pt>
                <c:pt idx="14">
                  <c:v>2273681</c:v>
                </c:pt>
                <c:pt idx="15">
                  <c:v>12569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1C-48E2-958B-A603A1BDEF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0559552"/>
        <c:axId val="580557584"/>
      </c:barChart>
      <c:catAx>
        <c:axId val="580559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557584"/>
        <c:crosses val="autoZero"/>
        <c:auto val="1"/>
        <c:lblAlgn val="ctr"/>
        <c:lblOffset val="100"/>
        <c:noMultiLvlLbl val="0"/>
      </c:catAx>
      <c:valAx>
        <c:axId val="580557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559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Stabl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hart 3 in Microsoft Word]NLCPFGEVFNAT'!$B$36:$B$50</c:f>
              <c:strCache>
                <c:ptCount val="15"/>
                <c:pt idx="0">
                  <c:v>NLCPFGEVFNAT glyco</c:v>
                </c:pt>
                <c:pt idx="1">
                  <c:v>NLCPFGEVFNAT Man4</c:v>
                </c:pt>
                <c:pt idx="2">
                  <c:v>NLCPFGEVFNAT Man5</c:v>
                </c:pt>
                <c:pt idx="3">
                  <c:v>NLCPFGEVFNAT Man6</c:v>
                </c:pt>
                <c:pt idx="4">
                  <c:v>NLCPFGEVFNAT Man7</c:v>
                </c:pt>
                <c:pt idx="5">
                  <c:v>NLCPFGEVFNAT Man8</c:v>
                </c:pt>
                <c:pt idx="6">
                  <c:v>NLCPFGEVFNAT G0F</c:v>
                </c:pt>
                <c:pt idx="7">
                  <c:v>NLCPFGEVFNAT G0F+GlcNAc</c:v>
                </c:pt>
                <c:pt idx="8">
                  <c:v>NLCPFGEVFNAT G1F</c:v>
                </c:pt>
                <c:pt idx="9">
                  <c:v>NLCPFGEVFNAT G2F</c:v>
                </c:pt>
                <c:pt idx="10">
                  <c:v>NLCPFGEVFNAT G2(F)</c:v>
                </c:pt>
                <c:pt idx="11">
                  <c:v>NLCPFGEVFNAT A1F</c:v>
                </c:pt>
                <c:pt idx="12">
                  <c:v>NLCPFGEVFNAT A2F</c:v>
                </c:pt>
                <c:pt idx="13">
                  <c:v>NLCPFGEVFNAT Complex</c:v>
                </c:pt>
                <c:pt idx="14">
                  <c:v>NLCPFGEVFNAT Complex + Hex</c:v>
                </c:pt>
              </c:strCache>
            </c:strRef>
          </c:cat>
          <c:val>
            <c:numRef>
              <c:f>'[Chart 3 in Microsoft Word]NLCPFGEVFNAT'!$C$36:$C$50</c:f>
              <c:numCache>
                <c:formatCode>General</c:formatCode>
                <c:ptCount val="15"/>
                <c:pt idx="0">
                  <c:v>1301336</c:v>
                </c:pt>
                <c:pt idx="1">
                  <c:v>0</c:v>
                </c:pt>
                <c:pt idx="2">
                  <c:v>114234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856188</c:v>
                </c:pt>
                <c:pt idx="7">
                  <c:v>2544013</c:v>
                </c:pt>
                <c:pt idx="8">
                  <c:v>679594</c:v>
                </c:pt>
                <c:pt idx="9">
                  <c:v>1580961</c:v>
                </c:pt>
                <c:pt idx="10">
                  <c:v>1832127</c:v>
                </c:pt>
                <c:pt idx="11">
                  <c:v>709857</c:v>
                </c:pt>
                <c:pt idx="12">
                  <c:v>0</c:v>
                </c:pt>
                <c:pt idx="13">
                  <c:v>1847585</c:v>
                </c:pt>
                <c:pt idx="14">
                  <c:v>31217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4D-41A2-B7F9-9A89C9F1A8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1640232"/>
        <c:axId val="541642856"/>
      </c:barChart>
      <c:catAx>
        <c:axId val="541640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1642856"/>
        <c:crosses val="autoZero"/>
        <c:auto val="1"/>
        <c:lblAlgn val="ctr"/>
        <c:lblOffset val="100"/>
        <c:noMultiLvlLbl val="0"/>
      </c:catAx>
      <c:valAx>
        <c:axId val="5416428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1640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Transient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hart 3 in Microsoft Word]NLCPFGEVFNAT'!$K$36:$K$50</c:f>
              <c:strCache>
                <c:ptCount val="15"/>
                <c:pt idx="0">
                  <c:v>NLCPFGEVFNAT glyco</c:v>
                </c:pt>
                <c:pt idx="1">
                  <c:v>NLCPFGEVFNAT Man4</c:v>
                </c:pt>
                <c:pt idx="2">
                  <c:v>NLCPFGEVFNAT Man5</c:v>
                </c:pt>
                <c:pt idx="3">
                  <c:v>NLCPFGEVFNAT Man6</c:v>
                </c:pt>
                <c:pt idx="4">
                  <c:v>NLCPFGEVFNAT Man7</c:v>
                </c:pt>
                <c:pt idx="5">
                  <c:v>NLCPFGEVFNAT Man8</c:v>
                </c:pt>
                <c:pt idx="6">
                  <c:v>NLCPFGEVFNAT G0F</c:v>
                </c:pt>
                <c:pt idx="7">
                  <c:v>NLCPFGEVFNAT G0F+GlcNAc</c:v>
                </c:pt>
                <c:pt idx="8">
                  <c:v>NLCPFGEVFNAT G1F</c:v>
                </c:pt>
                <c:pt idx="9">
                  <c:v>NLCPFGEVFNAT G2F</c:v>
                </c:pt>
                <c:pt idx="10">
                  <c:v>NLCPFGEVFNAT G2(F)</c:v>
                </c:pt>
                <c:pt idx="11">
                  <c:v>NLCPFGEVFNAT A1F</c:v>
                </c:pt>
                <c:pt idx="12">
                  <c:v>NLCPFGEVFNAT A2F</c:v>
                </c:pt>
                <c:pt idx="13">
                  <c:v>NLCPFGEVFNAT Complex</c:v>
                </c:pt>
                <c:pt idx="14">
                  <c:v>NLCPFGEVFNAT Complex + Hex</c:v>
                </c:pt>
              </c:strCache>
            </c:strRef>
          </c:cat>
          <c:val>
            <c:numRef>
              <c:f>'[Chart 3 in Microsoft Word]NLCPFGEVFNAT'!$L$36:$L$50</c:f>
              <c:numCache>
                <c:formatCode>General</c:formatCode>
                <c:ptCount val="15"/>
                <c:pt idx="0">
                  <c:v>0</c:v>
                </c:pt>
                <c:pt idx="1">
                  <c:v>714701</c:v>
                </c:pt>
                <c:pt idx="2">
                  <c:v>4311466</c:v>
                </c:pt>
                <c:pt idx="3">
                  <c:v>2252216</c:v>
                </c:pt>
                <c:pt idx="4">
                  <c:v>1003091</c:v>
                </c:pt>
                <c:pt idx="5">
                  <c:v>438964</c:v>
                </c:pt>
                <c:pt idx="6">
                  <c:v>2329768</c:v>
                </c:pt>
                <c:pt idx="7">
                  <c:v>1193820</c:v>
                </c:pt>
                <c:pt idx="8">
                  <c:v>2223761</c:v>
                </c:pt>
                <c:pt idx="9">
                  <c:v>2770397</c:v>
                </c:pt>
                <c:pt idx="10">
                  <c:v>371276</c:v>
                </c:pt>
                <c:pt idx="11">
                  <c:v>2619537</c:v>
                </c:pt>
                <c:pt idx="12">
                  <c:v>710884</c:v>
                </c:pt>
                <c:pt idx="13">
                  <c:v>1350958</c:v>
                </c:pt>
                <c:pt idx="14">
                  <c:v>13635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C0-47AA-A7D7-9C2EEF464B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0490344"/>
        <c:axId val="580483128"/>
      </c:barChart>
      <c:catAx>
        <c:axId val="580490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483128"/>
        <c:crosses val="autoZero"/>
        <c:auto val="1"/>
        <c:lblAlgn val="ctr"/>
        <c:lblOffset val="100"/>
        <c:noMultiLvlLbl val="0"/>
      </c:catAx>
      <c:valAx>
        <c:axId val="5804831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490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8533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9662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3210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127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0037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7242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3410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081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9549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750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5223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BF8121-E03B-4F92-9504-2F44BDF2481D}" type="datetimeFigureOut">
              <a:rPr lang="en-GB" smtClean="0"/>
              <a:t>09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E8D12-8AFD-416A-B202-923ED5A54E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7251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1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2468541" y="0"/>
            <a:ext cx="5279959" cy="6873669"/>
          </a:xfrm>
          <a:prstGeom prst="rect">
            <a:avLst/>
          </a:prstGeom>
          <a:noFill/>
          <a:ln>
            <a:noFill/>
            <a:prstDash/>
          </a:ln>
        </p:spPr>
      </p:pic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7704958" y="0"/>
            <a:ext cx="4390365" cy="6821024"/>
          </a:xfrm>
          <a:prstGeom prst="rect">
            <a:avLst/>
          </a:prstGeom>
          <a:noFill/>
          <a:ln>
            <a:noFill/>
            <a:prstDash/>
          </a:ln>
        </p:spPr>
      </p:pic>
      <p:sp>
        <p:nvSpPr>
          <p:cNvPr id="2" name="Rectangle 1"/>
          <p:cNvSpPr/>
          <p:nvPr/>
        </p:nvSpPr>
        <p:spPr>
          <a:xfrm>
            <a:off x="187569" y="1748087"/>
            <a:ext cx="2063262" cy="14260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</a:t>
            </a:r>
            <a:endParaRPr lang="en-GB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ike protein elastase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ycopeptide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ass retention time database containing data for 140 observed</a:t>
            </a:r>
            <a:r>
              <a:rPr lang="en-GB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ycopeptides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data for a further 306 inferred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ycopeptides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RT 2-60 min and key to glycan structures)</a:t>
            </a:r>
            <a:endParaRPr lang="en-GB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2664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2468244" y="660401"/>
            <a:ext cx="7782661" cy="2836778"/>
          </a:xfrm>
          <a:prstGeom prst="rect">
            <a:avLst/>
          </a:prstGeom>
          <a:noFill/>
          <a:ln>
            <a:noFill/>
            <a:prstDash/>
          </a:ln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2679364" y="3437916"/>
          <a:ext cx="6904127" cy="3048000"/>
        </p:xfrm>
        <a:graphic>
          <a:graphicData uri="http://schemas.openxmlformats.org/drawingml/2006/table">
            <a:tbl>
              <a:tblPr/>
              <a:tblGrid>
                <a:gridCol w="1306449">
                  <a:extLst>
                    <a:ext uri="{9D8B030D-6E8A-4147-A177-3AD203B41FA5}">
                      <a16:colId xmlns:a16="http://schemas.microsoft.com/office/drawing/2014/main" val="2278270913"/>
                    </a:ext>
                  </a:extLst>
                </a:gridCol>
                <a:gridCol w="1746243">
                  <a:extLst>
                    <a:ext uri="{9D8B030D-6E8A-4147-A177-3AD203B41FA5}">
                      <a16:colId xmlns:a16="http://schemas.microsoft.com/office/drawing/2014/main" val="3079336572"/>
                    </a:ext>
                  </a:extLst>
                </a:gridCol>
                <a:gridCol w="960434">
                  <a:extLst>
                    <a:ext uri="{9D8B030D-6E8A-4147-A177-3AD203B41FA5}">
                      <a16:colId xmlns:a16="http://schemas.microsoft.com/office/drawing/2014/main" val="3173464865"/>
                    </a:ext>
                  </a:extLst>
                </a:gridCol>
                <a:gridCol w="649990">
                  <a:extLst>
                    <a:ext uri="{9D8B030D-6E8A-4147-A177-3AD203B41FA5}">
                      <a16:colId xmlns:a16="http://schemas.microsoft.com/office/drawing/2014/main" val="3960568499"/>
                    </a:ext>
                  </a:extLst>
                </a:gridCol>
                <a:gridCol w="1125356">
                  <a:extLst>
                    <a:ext uri="{9D8B030D-6E8A-4147-A177-3AD203B41FA5}">
                      <a16:colId xmlns:a16="http://schemas.microsoft.com/office/drawing/2014/main" val="3182740370"/>
                    </a:ext>
                  </a:extLst>
                </a:gridCol>
                <a:gridCol w="1115655">
                  <a:extLst>
                    <a:ext uri="{9D8B030D-6E8A-4147-A177-3AD203B41FA5}">
                      <a16:colId xmlns:a16="http://schemas.microsoft.com/office/drawing/2014/main" val="816749425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convoluted</a:t>
                      </a:r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bserved Mas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mul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culated Mas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ror (pp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gment ion assignme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e sequenc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77213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01215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.06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7 H10 N2 O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.06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51327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.13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2 H19 N3 O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.13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92642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6.24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5 H34 N6 O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6.24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53633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7.27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8 H39 N7 O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7.28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47533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8.32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2 H46 N8 O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8.32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296689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6.33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2 H48 N8 O12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6.33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27172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9.41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2 H48 N8 O12 C8 H13 N O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9.41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GlcN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T GlcN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62185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1.40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2 H46 N8 O11 C8 H13 N O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1.4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GlcNAc - H2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T GlcN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03785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0.36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8 H39 N7 O9 C8 H13 N O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0.36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6 GlcNAc - H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 GlcNAc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316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9.32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5 H34 N6 O8 C8 H13 N O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9.32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5 GlcNAc - H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 GlcNAc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8416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1.30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2 H43 N7 O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1.30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7 - NH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44383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0.25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8 H36 N6 O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0.25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6 - NH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10342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9.21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5 H31 N5 O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9.21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5 - NH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VF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887022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217414" y="2078790"/>
            <a:ext cx="2250830" cy="17338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</a:t>
            </a:r>
            <a:endParaRPr lang="en-GB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seudo MS3 fragmentation analysis of RBD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ycopeptide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ump GEVFNAT-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cNAc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343) with </a:t>
            </a:r>
            <a:r>
              <a:rPr lang="en-GB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agment ion assignment and mass errors in parts per million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Labels indicate the amino acid residue(s) and sugars associated with their characteristic mass shift on fragmentation, which was used for de-novo sequencing.</a:t>
            </a:r>
            <a:endParaRPr lang="en-GB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49204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2952982" y="689810"/>
            <a:ext cx="8598567" cy="5542547"/>
          </a:xfrm>
          <a:prstGeom prst="rect">
            <a:avLst/>
          </a:prstGeom>
          <a:noFill/>
          <a:ln>
            <a:noFill/>
            <a:prstDash/>
          </a:ln>
        </p:spPr>
      </p:pic>
      <p:sp>
        <p:nvSpPr>
          <p:cNvPr id="2" name="Rectangle 1"/>
          <p:cNvSpPr/>
          <p:nvPr/>
        </p:nvSpPr>
        <p:spPr>
          <a:xfrm>
            <a:off x="573197" y="1864481"/>
            <a:ext cx="2379785" cy="30675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</a:t>
            </a:r>
            <a:endParaRPr lang="en-GB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C-MSMS “discovery” mode used to generate the Spike protein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ycopeptide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RTF database. Schematic representation of the MRTF “discovery workflow” use to enable the simpler “analytical workflow” shown in Figure 1. Specific colors (yellow, blue, red, orange and green) represent elastase-cleaved peptides. Shades of the same color represent three possible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ycoforms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e same peptide which resolve only partially by HPLC. The five workflow stages are 1. reduction/alkylation and elastase digestion 2. reversed phase LC-MS  3. glycan assignment 4. peptide assignment 5. database population.  </a:t>
            </a:r>
            <a:endParaRPr lang="en-GB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3523665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/>
          </p:nvPr>
        </p:nvGraphicFramePr>
        <p:xfrm>
          <a:off x="745958" y="6817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>
            <p:extLst/>
          </p:nvPr>
        </p:nvGraphicFramePr>
        <p:xfrm>
          <a:off x="874295" y="281137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>
            <p:extLst/>
          </p:nvPr>
        </p:nvGraphicFramePr>
        <p:xfrm>
          <a:off x="5446295" y="6817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Rectangle 1"/>
          <p:cNvSpPr/>
          <p:nvPr/>
        </p:nvSpPr>
        <p:spPr>
          <a:xfrm>
            <a:off x="6096000" y="3808517"/>
            <a:ext cx="6096000" cy="74892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80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4. </a:t>
            </a:r>
            <a:endParaRPr lang="en-GB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SK-CHO technical replicates A, B &amp; C</a:t>
            </a:r>
            <a:endParaRPr lang="en-GB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0367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/>
          </p:nvPr>
        </p:nvGraphicFramePr>
        <p:xfrm>
          <a:off x="601579" y="99761"/>
          <a:ext cx="4572000" cy="3257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>
            <p:extLst/>
          </p:nvPr>
        </p:nvGraphicFramePr>
        <p:xfrm>
          <a:off x="401053" y="3465095"/>
          <a:ext cx="4572000" cy="30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>
            <p:extLst/>
          </p:nvPr>
        </p:nvGraphicFramePr>
        <p:xfrm>
          <a:off x="5566860" y="99761"/>
          <a:ext cx="4619625" cy="3019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Rectangle 1"/>
          <p:cNvSpPr/>
          <p:nvPr/>
        </p:nvSpPr>
        <p:spPr>
          <a:xfrm>
            <a:off x="6611815" y="4039277"/>
            <a:ext cx="6096000" cy="74892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80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5. </a:t>
            </a:r>
            <a:endParaRPr lang="en-GB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replicates</a:t>
            </a:r>
            <a:endParaRPr lang="en-GB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2586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1</TotalTime>
  <Words>400</Words>
  <Application>Microsoft Office PowerPoint</Application>
  <PresentationFormat>Widescreen</PresentationFormat>
  <Paragraphs>10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d Chalk</dc:creator>
  <cp:lastModifiedBy>Rod Chalk</cp:lastModifiedBy>
  <cp:revision>6</cp:revision>
  <dcterms:created xsi:type="dcterms:W3CDTF">2021-01-06T12:11:25Z</dcterms:created>
  <dcterms:modified xsi:type="dcterms:W3CDTF">2021-07-09T12:40:27Z</dcterms:modified>
</cp:coreProperties>
</file>